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4" r:id="rId3"/>
    <p:sldId id="265" r:id="rId4"/>
    <p:sldId id="26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1234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9037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2415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s://doi.org/10.1016/j.jhep.2023.06.003" TargetMode="External"/><Relationship Id="rId4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tiff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53EBF61-C8F8-532D-8288-A5F9C7AAC8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6328" y="1196752"/>
            <a:ext cx="7691343" cy="4261420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5301208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Qadri and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ki-Järvine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4-06087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Created with BioRender.com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467380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Pathogenesis of liver steatosis in type 2 diabetes</a:t>
            </a:r>
            <a:endParaRPr lang="en-GB" sz="1800" b="1" dirty="0"/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ECB1F56F-57D1-4387-BBD5-7B41A65F1B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3852" y="1784128"/>
            <a:ext cx="7452320" cy="3085032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467380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Consequences of steatosis</a:t>
            </a:r>
            <a:endParaRPr lang="en-GB" sz="18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352919-A58E-5E44-F523-CD220E7BAAA8}"/>
              </a:ext>
            </a:extLst>
          </p:cNvPr>
          <p:cNvSpPr txBox="1"/>
          <p:nvPr/>
        </p:nvSpPr>
        <p:spPr>
          <a:xfrm>
            <a:off x="323528" y="5301208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Qadri and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ki-Järvine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4-06087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Created with BioRender.com</a:t>
            </a:r>
          </a:p>
        </p:txBody>
      </p:sp>
    </p:spTree>
    <p:extLst>
      <p:ext uri="{BB962C8B-B14F-4D97-AF65-F5344CB8AC3E}">
        <p14:creationId xmlns:p14="http://schemas.microsoft.com/office/powerpoint/2010/main" val="3516939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242CDDF-0826-000E-C35C-163415D46B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501" y="1340768"/>
            <a:ext cx="8160997" cy="3304184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467380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Updated classification of </a:t>
            </a:r>
            <a:r>
              <a:rPr lang="en-US" sz="1800" b="1" dirty="0" err="1"/>
              <a:t>steatotic</a:t>
            </a:r>
            <a:r>
              <a:rPr lang="en-US" sz="1800" b="1" dirty="0"/>
              <a:t> liver disease</a:t>
            </a:r>
            <a:endParaRPr lang="en-GB" sz="18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E87B18E-1300-91F5-12D8-B3E95D8F83E8}"/>
              </a:ext>
            </a:extLst>
          </p:cNvPr>
          <p:cNvSpPr txBox="1"/>
          <p:nvPr/>
        </p:nvSpPr>
        <p:spPr>
          <a:xfrm>
            <a:off x="323528" y="4752624"/>
            <a:ext cx="7920880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Qadri and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ki-Järvine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4-06087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2023 American Association for the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tudy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of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iver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eases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AASLD), European Association for the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tudy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of the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iver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EASL), and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undación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línica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édica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Sur, A.C. </a:t>
            </a:r>
            <a:r>
              <a:rPr kumimoji="0" lang="fr-F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ublished</a:t>
            </a:r>
            <a:r>
              <a:rPr kumimoji="0" lang="fr-F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by Wolters Kluwer/Elsevier B.V/ Elsevier España, S.L.U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apted from Rinella et al (2023) Journal of Hepatology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s://doi.org/10.1016/j.jhep.2023.06.003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with permission from Elsevier. Created with BioRender.com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highlight>
                <a:srgbClr val="FF00FF"/>
              </a:highlight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2026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0B0AE1A-23FC-56CB-C3B4-95DE6493B7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249" y="1484784"/>
            <a:ext cx="4355876" cy="28808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7FF2E34-C9CB-39B5-D830-D974CA53A7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5076" y="1484784"/>
            <a:ext cx="4346973" cy="376468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C7987C9-2655-98B6-CC26-8FA88F2EB2CC}"/>
              </a:ext>
            </a:extLst>
          </p:cNvPr>
          <p:cNvSpPr txBox="1"/>
          <p:nvPr/>
        </p:nvSpPr>
        <p:spPr>
          <a:xfrm>
            <a:off x="323528" y="5301208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Qadri and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ki-Järvine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4) Diabetologia DOI 10.1007/s00125-024-06087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Created with BioRender.com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39537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Current recommendations for screening of advanced liver fibrosis in type 2 diabetes</a:t>
            </a:r>
            <a:endParaRPr lang="en-GB" sz="18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B7B45EF-31DF-4496-C8CA-765C2153C70F}"/>
              </a:ext>
            </a:extLst>
          </p:cNvPr>
          <p:cNvSpPr txBox="1"/>
          <p:nvPr/>
        </p:nvSpPr>
        <p:spPr>
          <a:xfrm>
            <a:off x="345378" y="5385779"/>
            <a:ext cx="5760640" cy="272415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ELF, Enhanced Liver Fibrosis; FIB-4, Fibrosis-4; LSM, liver stiffness measurement; TE, transient elastography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79996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88</Words>
  <Application>Microsoft Office PowerPoint</Application>
  <PresentationFormat>On-screen Show (4:3)</PresentationFormat>
  <Paragraphs>25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52</cp:revision>
  <dcterms:created xsi:type="dcterms:W3CDTF">2016-06-15T12:53:43Z</dcterms:created>
  <dcterms:modified xsi:type="dcterms:W3CDTF">2024-02-06T16:48:54Z</dcterms:modified>
</cp:coreProperties>
</file>